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396" y="12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9736BE-4659-71C0-C552-8AB13A73E3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3866B5B-1A6B-6B4B-25A9-649B73DAB8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5AE4C1-8045-2B25-05F2-25551E7CF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A60139-B603-18DE-3C42-F16F83AE7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866919-5997-18AB-CA8C-F68DDFC2F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0403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22D3FA-D84E-169E-B9CC-2E1D8108D4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9E82B9D-F0F2-A3A9-E821-4AF82C98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9F41CDA-33A0-B537-7548-D7EA2A352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F0F1D4-C164-93C2-EFE7-55BAE2301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2E2F95-BE60-BC22-659E-74EFAA628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73741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AF81BF7-25AE-347A-1A98-C5F9BA3FAB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D81B0CB-70D0-8A79-5266-B388763767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E19844-CF9C-6995-9BF0-0AF467760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8FB4DBA-FD53-3979-5F3C-7BACC9734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A1577B-8735-9477-7B32-82A5CAFA7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7016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006307-E232-69C2-EC6C-4C45DAF37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B5FB5F5-DC9E-AE19-9C09-7F065E628A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98D7013-1E89-F031-16F2-EC6902590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D63294-F8D8-BA11-E5B2-772A55908E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246D70-5DFD-25D1-71C6-5D03667BA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7790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31CDBA-5B62-2116-A410-54190D6399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B3825ED-8E9A-DAEB-F03C-12D4B9A6C9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81586A-B390-2747-E6AC-B93FE29EEC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2BFF60C-D728-35FD-7728-CD9EC9E4C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664F86-8970-3986-DFBB-5BD7E4FC3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816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6F49B8C-E3ED-0CE4-9482-9132AAB91E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BE0F83A-282C-F349-E83F-80BFECFD88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9D6674C-B348-E448-BAB2-E25A7D7A94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6E6F442-7822-E37B-5E4B-48D09FA28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3028CE5-6E3F-8F7A-12C6-6673C5ACF4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5B49ED2-D56A-0357-5959-8430DE78F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7795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71D192-6857-F02A-E5C2-BEC6BE82B6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C3B3CE6-211C-B681-4E78-43779D6F30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AF933D9-8763-64C8-7CEE-FA8E6E1851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71E1CFA-88DB-A592-58DD-96A172E76A6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AA9ED6E-91ED-9FBC-9D81-8CA2D19C9E8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205A553-2224-E818-2E9D-7DAD438589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209DAAC-2734-AED8-F1CD-12FC78CEE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12C162A-5144-3451-324D-CD69B6B1A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2202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99D956-95B5-BFD5-97B3-65EF027659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835413A-FE76-C286-9EBF-E238A23ED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FEA56A4-D244-56A6-4814-E4422F15C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4599483-FFF5-3792-6734-256EE076D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100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8C559F5-DB11-88C3-00B0-C0EFCB7597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DFDAC2C-0437-C91B-7336-FEAE1D219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1059CC7-AFBA-93CD-9511-AC3F7D184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19227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5C2019-79E9-5F5B-A164-5E3D8CDC4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64B8024-CD22-79D8-0CED-0F8F409B7C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E9713D9-CFC1-170F-8626-CC73602EA4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2535F7D-90CB-1E22-D89B-FE682DF13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55AB820-D249-FD17-5813-8C1385743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A1936F9-486D-C0AF-5663-C91DAAAB4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683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A355E2-277B-4D6A-AFAB-5B0EC120E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89977F9-AD84-2753-CFFF-829CFBC954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F7D775D-7B39-4FDB-B179-B55DB479C7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9E06255-846B-2F13-A426-983BAA6DD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B62797-52D6-2A4C-C8E6-0B21416133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AF7912F-7EEA-2635-AC5F-AB2141A58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159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5178292-46B8-7FCA-94C0-192C5A8F72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70C37C6-9353-0D42-D99D-93032888E6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60AAE9-CA28-A03E-04C4-7F1668BD99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86C17-535F-4E38-8A9E-1E99F3EE025B}" type="datetimeFigureOut">
              <a:rPr kumimoji="1" lang="ja-JP" altLang="en-US" smtClean="0"/>
              <a:t>2023/9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443CFF-4A51-C17D-A7CB-7A36FB1BFC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59F1EF-0610-0A7B-36F7-F27E32E3D6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C76552-318A-4EB6-BDCE-CC5CE6FD8F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1269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15B13B2F-08A5-4AF6-CA5F-C8DFED2B30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0657428"/>
              </p:ext>
            </p:extLst>
          </p:nvPr>
        </p:nvGraphicFramePr>
        <p:xfrm>
          <a:off x="1636370" y="1429544"/>
          <a:ext cx="7773489" cy="4351328"/>
        </p:xfrm>
        <a:graphic>
          <a:graphicData uri="http://schemas.openxmlformats.org/drawingml/2006/table">
            <a:tbl>
              <a:tblPr/>
              <a:tblGrid>
                <a:gridCol w="222807">
                  <a:extLst>
                    <a:ext uri="{9D8B030D-6E8A-4147-A177-3AD203B41FA5}">
                      <a16:colId xmlns:a16="http://schemas.microsoft.com/office/drawing/2014/main" val="3671336722"/>
                    </a:ext>
                  </a:extLst>
                </a:gridCol>
                <a:gridCol w="387849">
                  <a:extLst>
                    <a:ext uri="{9D8B030D-6E8A-4147-A177-3AD203B41FA5}">
                      <a16:colId xmlns:a16="http://schemas.microsoft.com/office/drawing/2014/main" val="1666858526"/>
                    </a:ext>
                  </a:extLst>
                </a:gridCol>
                <a:gridCol w="379597">
                  <a:extLst>
                    <a:ext uri="{9D8B030D-6E8A-4147-A177-3AD203B41FA5}">
                      <a16:colId xmlns:a16="http://schemas.microsoft.com/office/drawing/2014/main" val="3996325897"/>
                    </a:ext>
                  </a:extLst>
                </a:gridCol>
                <a:gridCol w="247563">
                  <a:extLst>
                    <a:ext uri="{9D8B030D-6E8A-4147-A177-3AD203B41FA5}">
                      <a16:colId xmlns:a16="http://schemas.microsoft.com/office/drawing/2014/main" val="2048707728"/>
                    </a:ext>
                  </a:extLst>
                </a:gridCol>
                <a:gridCol w="635413">
                  <a:extLst>
                    <a:ext uri="{9D8B030D-6E8A-4147-A177-3AD203B41FA5}">
                      <a16:colId xmlns:a16="http://schemas.microsoft.com/office/drawing/2014/main" val="2747967331"/>
                    </a:ext>
                  </a:extLst>
                </a:gridCol>
                <a:gridCol w="602404">
                  <a:extLst>
                    <a:ext uri="{9D8B030D-6E8A-4147-A177-3AD203B41FA5}">
                      <a16:colId xmlns:a16="http://schemas.microsoft.com/office/drawing/2014/main" val="3836575022"/>
                    </a:ext>
                  </a:extLst>
                </a:gridCol>
                <a:gridCol w="577648">
                  <a:extLst>
                    <a:ext uri="{9D8B030D-6E8A-4147-A177-3AD203B41FA5}">
                      <a16:colId xmlns:a16="http://schemas.microsoft.com/office/drawing/2014/main" val="1370462136"/>
                    </a:ext>
                  </a:extLst>
                </a:gridCol>
                <a:gridCol w="577648">
                  <a:extLst>
                    <a:ext uri="{9D8B030D-6E8A-4147-A177-3AD203B41FA5}">
                      <a16:colId xmlns:a16="http://schemas.microsoft.com/office/drawing/2014/main" val="3016635932"/>
                    </a:ext>
                  </a:extLst>
                </a:gridCol>
                <a:gridCol w="412606">
                  <a:extLst>
                    <a:ext uri="{9D8B030D-6E8A-4147-A177-3AD203B41FA5}">
                      <a16:colId xmlns:a16="http://schemas.microsoft.com/office/drawing/2014/main" val="3768609444"/>
                    </a:ext>
                  </a:extLst>
                </a:gridCol>
                <a:gridCol w="222807">
                  <a:extLst>
                    <a:ext uri="{9D8B030D-6E8A-4147-A177-3AD203B41FA5}">
                      <a16:colId xmlns:a16="http://schemas.microsoft.com/office/drawing/2014/main" val="1438581154"/>
                    </a:ext>
                  </a:extLst>
                </a:gridCol>
                <a:gridCol w="387849">
                  <a:extLst>
                    <a:ext uri="{9D8B030D-6E8A-4147-A177-3AD203B41FA5}">
                      <a16:colId xmlns:a16="http://schemas.microsoft.com/office/drawing/2014/main" val="3612058456"/>
                    </a:ext>
                  </a:extLst>
                </a:gridCol>
                <a:gridCol w="379597">
                  <a:extLst>
                    <a:ext uri="{9D8B030D-6E8A-4147-A177-3AD203B41FA5}">
                      <a16:colId xmlns:a16="http://schemas.microsoft.com/office/drawing/2014/main" val="177642104"/>
                    </a:ext>
                  </a:extLst>
                </a:gridCol>
                <a:gridCol w="247563">
                  <a:extLst>
                    <a:ext uri="{9D8B030D-6E8A-4147-A177-3AD203B41FA5}">
                      <a16:colId xmlns:a16="http://schemas.microsoft.com/office/drawing/2014/main" val="190386299"/>
                    </a:ext>
                  </a:extLst>
                </a:gridCol>
                <a:gridCol w="635413">
                  <a:extLst>
                    <a:ext uri="{9D8B030D-6E8A-4147-A177-3AD203B41FA5}">
                      <a16:colId xmlns:a16="http://schemas.microsoft.com/office/drawing/2014/main" val="3765074961"/>
                    </a:ext>
                  </a:extLst>
                </a:gridCol>
                <a:gridCol w="602404">
                  <a:extLst>
                    <a:ext uri="{9D8B030D-6E8A-4147-A177-3AD203B41FA5}">
                      <a16:colId xmlns:a16="http://schemas.microsoft.com/office/drawing/2014/main" val="4184609407"/>
                    </a:ext>
                  </a:extLst>
                </a:gridCol>
                <a:gridCol w="577648">
                  <a:extLst>
                    <a:ext uri="{9D8B030D-6E8A-4147-A177-3AD203B41FA5}">
                      <a16:colId xmlns:a16="http://schemas.microsoft.com/office/drawing/2014/main" val="3400108862"/>
                    </a:ext>
                  </a:extLst>
                </a:gridCol>
                <a:gridCol w="577648">
                  <a:extLst>
                    <a:ext uri="{9D8B030D-6E8A-4147-A177-3AD203B41FA5}">
                      <a16:colId xmlns:a16="http://schemas.microsoft.com/office/drawing/2014/main" val="2764119550"/>
                    </a:ext>
                  </a:extLst>
                </a:gridCol>
                <a:gridCol w="99025">
                  <a:extLst>
                    <a:ext uri="{9D8B030D-6E8A-4147-A177-3AD203B41FA5}">
                      <a16:colId xmlns:a16="http://schemas.microsoft.com/office/drawing/2014/main" val="2188800276"/>
                    </a:ext>
                  </a:extLst>
                </a:gridCol>
              </a:tblGrid>
              <a:tr h="185672">
                <a:tc gridSpan="8">
                  <a:txBody>
                    <a:bodyPr/>
                    <a:lstStyle/>
                    <a:p>
                      <a:pPr algn="ctr" fontAlgn="t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iary of use of test solution and anxiolytics</a:t>
                      </a:r>
                    </a:p>
                  </a:txBody>
                  <a:tcPr marL="4126" marR="4126" marT="4126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.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and Time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vailability of test solution carrying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se of test solution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me of anxiolytics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ber of anxiolytics tablets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2825345"/>
                  </a:ext>
                </a:extLst>
              </a:tr>
              <a:tr h="113054">
                <a:tc>
                  <a:txBody>
                    <a:bodyPr/>
                    <a:lstStyle/>
                    <a:p>
                      <a:pPr algn="l" fontAlgn="t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4" gridSpan="3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earcher Entry</a:t>
                      </a:r>
                      <a:b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</a:br>
                      <a:b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xaminee's identification code</a:t>
                      </a:r>
                      <a:b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</a:br>
                      <a:b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llection day</a:t>
                      </a:r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  <a:t>　</a:t>
                      </a:r>
                      <a:r>
                        <a:rPr lang="en-US" sz="500" b="0" i="0" u="sng" strike="noStrike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  <a:t>　　</a:t>
                      </a:r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</a:t>
                      </a:r>
                      <a:r>
                        <a:rPr lang="en-US" sz="500" b="0" i="0" u="sng" strike="noStrike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  <a:t>　　</a:t>
                      </a:r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/20__</a:t>
                      </a:r>
                      <a:r>
                        <a:rPr lang="en-US" sz="500" b="0" i="0" u="sng" strike="noStrike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  <a:t>　　</a:t>
                      </a:r>
                      <a:b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</a:br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  <a:t>（</a:t>
                      </a:r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e-observation period / Period of test solution use</a:t>
                      </a:r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ＭＳ ゴシック" panose="020B0609070205080204" pitchFamily="49" charset="-128"/>
                          <a:ea typeface="ＭＳ ゴシック" panose="020B0609070205080204" pitchFamily="49" charset="-128"/>
                        </a:rPr>
                        <a:t>）</a:t>
                      </a:r>
                      <a:endParaRPr 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4"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340819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l" fontAlgn="t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4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___/___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0300278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l" fontAlgn="t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6355597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l" fontAlgn="t"/>
                      <a:endParaRPr lang="ja-JP" altLang="en-US" sz="5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6768347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6103191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.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and Time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vailability of test solution carrying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se of test solution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me of anxiolytics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mber of anxiolytics tablets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0276555"/>
                  </a:ext>
                </a:extLst>
              </a:tr>
              <a:tr h="113054"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3275629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1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r" fontAlgn="ctr"/>
                      <a:r>
                        <a:rPr lang="en-US" altLang="ja-JP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___/___</a:t>
                      </a:r>
                      <a:r>
                        <a:rPr lang="ja-JP" alt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游ゴシック" panose="020B0400000000000000" pitchFamily="50" charset="-128"/>
                          <a:ea typeface="游ゴシック" panose="020B0400000000000000" pitchFamily="50" charset="-128"/>
                        </a:rPr>
                        <a:t>　　</a:t>
                      </a:r>
                      <a:endParaRPr lang="ja-JP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5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___/___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7976349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589941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15879380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8318563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5052148"/>
                  </a:ext>
                </a:extLst>
              </a:tr>
              <a:tr h="113054"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4074542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2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___/___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6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___/___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1477455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5706431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9824531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0367287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0611260"/>
                  </a:ext>
                </a:extLst>
              </a:tr>
              <a:tr h="113054"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3612225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3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___/___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y 7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___/___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601319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2944107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6749311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1338095"/>
                  </a:ext>
                </a:extLst>
              </a:tr>
              <a:tr h="18567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'clock</a:t>
                      </a:r>
                    </a:p>
                  </a:txBody>
                  <a:tcPr marL="4126" marR="4126" marT="412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es / No</a:t>
                      </a: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　</a:t>
                      </a:r>
                    </a:p>
                  </a:txBody>
                  <a:tcPr marL="4126" marR="4126" marT="4126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4126" marR="4126" marT="412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5771690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69B27DC-2EAA-A7FC-0F78-8620BE7FF0F5}"/>
              </a:ext>
            </a:extLst>
          </p:cNvPr>
          <p:cNvSpPr txBox="1"/>
          <p:nvPr/>
        </p:nvSpPr>
        <p:spPr>
          <a:xfrm>
            <a:off x="91439" y="157171"/>
            <a:ext cx="7957357" cy="6217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2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: Diary of use of test solution and anxiolytics</a:t>
            </a:r>
            <a:endParaRPr lang="ja-JP" altLang="ja-JP" sz="1600" b="1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3810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375</Words>
  <Application>Microsoft Office PowerPoint</Application>
  <PresentationFormat>ワイド画面</PresentationFormat>
  <Paragraphs>2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ゴシック</vt:lpstr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ruka Amitani</dc:creator>
  <cp:lastModifiedBy>Ryusei Nishi</cp:lastModifiedBy>
  <cp:revision>8</cp:revision>
  <dcterms:created xsi:type="dcterms:W3CDTF">2022-11-21T02:12:56Z</dcterms:created>
  <dcterms:modified xsi:type="dcterms:W3CDTF">2023-09-29T07:36:54Z</dcterms:modified>
</cp:coreProperties>
</file>